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9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332" y="56"/>
      </p:cViewPr>
      <p:guideLst>
        <p:guide orient="horz" pos="2160"/>
        <p:guide pos="29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1344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541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580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88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3792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756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30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2068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146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6033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3846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39647-985A-44C9-8EB5-610EFB54D6E5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2BF759-C965-4795-A44E-D0D46B6A93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578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B8EBE8FA-D04A-6A4B-ADCF-70453D2B5E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7011882"/>
              </p:ext>
            </p:extLst>
          </p:nvPr>
        </p:nvGraphicFramePr>
        <p:xfrm>
          <a:off x="94971" y="2902726"/>
          <a:ext cx="9002717" cy="3840483"/>
        </p:xfrm>
        <a:graphic>
          <a:graphicData uri="http://schemas.openxmlformats.org/drawingml/2006/table">
            <a:tbl>
              <a:tblPr>
                <a:tableStyleId>{93296810-A885-4BE3-A3E7-6D5BEEA58F35}</a:tableStyleId>
              </a:tblPr>
              <a:tblGrid>
                <a:gridCol w="167621">
                  <a:extLst>
                    <a:ext uri="{9D8B030D-6E8A-4147-A177-3AD203B41FA5}">
                      <a16:colId xmlns:a16="http://schemas.microsoft.com/office/drawing/2014/main" val="2970984046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3581382832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128411719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4010225651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1196838084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2503729580"/>
                    </a:ext>
                  </a:extLst>
                </a:gridCol>
                <a:gridCol w="780518">
                  <a:extLst>
                    <a:ext uri="{9D8B030D-6E8A-4147-A177-3AD203B41FA5}">
                      <a16:colId xmlns:a16="http://schemas.microsoft.com/office/drawing/2014/main" val="37795732"/>
                    </a:ext>
                  </a:extLst>
                </a:gridCol>
                <a:gridCol w="691998">
                  <a:extLst>
                    <a:ext uri="{9D8B030D-6E8A-4147-A177-3AD203B41FA5}">
                      <a16:colId xmlns:a16="http://schemas.microsoft.com/office/drawing/2014/main" val="3910284532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3017621285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1065749387"/>
                    </a:ext>
                  </a:extLst>
                </a:gridCol>
                <a:gridCol w="629486">
                  <a:extLst>
                    <a:ext uri="{9D8B030D-6E8A-4147-A177-3AD203B41FA5}">
                      <a16:colId xmlns:a16="http://schemas.microsoft.com/office/drawing/2014/main" val="3269289914"/>
                    </a:ext>
                  </a:extLst>
                </a:gridCol>
                <a:gridCol w="843030">
                  <a:extLst>
                    <a:ext uri="{9D8B030D-6E8A-4147-A177-3AD203B41FA5}">
                      <a16:colId xmlns:a16="http://schemas.microsoft.com/office/drawing/2014/main" val="689345952"/>
                    </a:ext>
                  </a:extLst>
                </a:gridCol>
                <a:gridCol w="736258">
                  <a:extLst>
                    <a:ext uri="{9D8B030D-6E8A-4147-A177-3AD203B41FA5}">
                      <a16:colId xmlns:a16="http://schemas.microsoft.com/office/drawing/2014/main" val="2209525175"/>
                    </a:ext>
                  </a:extLst>
                </a:gridCol>
              </a:tblGrid>
              <a:tr h="3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Reference </a:t>
                      </a:r>
                      <a:r>
                        <a:rPr lang="en-US" sz="900" u="none" strike="noStrike" dirty="0">
                          <a:effectLst/>
                        </a:rPr>
                        <a:t>Spot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Adiponectin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Acrp3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Amphiregulin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giopoietin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giopoietin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ngiopoietin-like 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BAFF/</a:t>
                      </a:r>
                      <a:r>
                        <a:rPr lang="en-US" sz="900" u="none" strike="noStrike" dirty="0" err="1">
                          <a:effectLst/>
                        </a:rPr>
                        <a:t>BLyS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TNFSF13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1q R1/CD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2/JE/MCP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CL3/CCL4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MIP-1</a:t>
                      </a:r>
                      <a:r>
                        <a:rPr lang="el-GR" sz="900" u="none" strike="noStrike" dirty="0">
                          <a:effectLst/>
                        </a:rPr>
                        <a:t>α/β</a:t>
                      </a:r>
                      <a:endParaRPr lang="el-GR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5/RANT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ference Spot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886050237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6/C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11/Eotax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12/MCP-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17/TAR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19/MIP-3</a:t>
                      </a:r>
                      <a:r>
                        <a:rPr lang="el-GR" sz="900" u="none" strike="noStrike">
                          <a:effectLst/>
                        </a:rPr>
                        <a:t>β</a:t>
                      </a:r>
                      <a:endParaRPr lang="el-G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20/MIP-3</a:t>
                      </a:r>
                      <a:r>
                        <a:rPr lang="el-GR" sz="900" u="none" strike="noStrike">
                          <a:effectLst/>
                        </a:rPr>
                        <a:t>α</a:t>
                      </a:r>
                      <a:endParaRPr lang="el-G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21/6Ckin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CL22/MD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D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D40/TNFRSF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1314363442"/>
                  </a:ext>
                </a:extLst>
              </a:tr>
              <a:tr h="713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D16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hemer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hitinase 3-like 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agulation Factor III/Tissue Facto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mplement Component C5/C5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mplement Factor 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-Reactive Protein/CR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X3CL1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err="1" smtClean="0">
                          <a:effectLst/>
                        </a:rPr>
                        <a:t>Fractalkin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XCL1/K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XCL2/MIP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2119335062"/>
                  </a:ext>
                </a:extLst>
              </a:tr>
              <a:tr h="3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XCL9/MI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XCL10/IP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XCL11/I-TA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XCL13/BLC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BCA-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XCL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ystatin 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KK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DPPIV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CD2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EG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Endoglin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CD1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Endosta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>
                          <a:effectLst/>
                        </a:rPr>
                        <a:t>Fetuin</a:t>
                      </a:r>
                      <a:r>
                        <a:rPr lang="en-US" sz="900" u="none" strike="noStrike" dirty="0">
                          <a:effectLst/>
                        </a:rPr>
                        <a:t> A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AHSG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3671767399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GF acidi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GF-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Flt-3 Ligand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as 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-CS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DF-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GM-CS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HG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CAM-1/CD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FN-</a:t>
                      </a:r>
                      <a:r>
                        <a:rPr lang="el-GR" sz="900" u="none" strike="noStrike">
                          <a:effectLst/>
                        </a:rPr>
                        <a:t>γ</a:t>
                      </a:r>
                      <a:endParaRPr lang="el-G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GFBP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GFBP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4189304485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GFBP-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GFBP-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GFBP-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</a:t>
                      </a:r>
                      <a:r>
                        <a:rPr lang="el-GR" sz="900" u="none" strike="noStrike">
                          <a:effectLst/>
                        </a:rPr>
                        <a:t>α/</a:t>
                      </a:r>
                      <a:r>
                        <a:rPr lang="en-US" sz="900" u="none" strike="noStrike">
                          <a:effectLst/>
                        </a:rPr>
                        <a:t>IL-1F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</a:t>
                      </a:r>
                      <a:r>
                        <a:rPr lang="el-GR" sz="900" u="none" strike="noStrike">
                          <a:effectLst/>
                        </a:rPr>
                        <a:t>β/</a:t>
                      </a:r>
                      <a:r>
                        <a:rPr lang="en-US" sz="900" u="none" strike="noStrike">
                          <a:effectLst/>
                        </a:rPr>
                        <a:t>IL-1F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ra/IL-1F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3873836436"/>
                  </a:ext>
                </a:extLst>
              </a:tr>
              <a:tr h="20070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2 p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17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27 p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28A/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IL-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LDL 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2890280382"/>
                  </a:ext>
                </a:extLst>
              </a:tr>
              <a:tr h="71327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Lep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LI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Lipocalin-2/NGA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LI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-CS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MP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MP-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MMP-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err="1" smtClean="0">
                          <a:effectLst/>
                        </a:rPr>
                        <a:t>Myelo</a:t>
                      </a:r>
                      <a:r>
                        <a:rPr lang="en-US" sz="900" u="none" strike="noStrike" dirty="0" smtClean="0">
                          <a:effectLst/>
                        </a:rPr>
                        <a:t>-peroxid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Osteopontin (OPN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Osteoprotegerin/TNFRSF11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PD-ECGF</a:t>
                      </a:r>
                      <a:r>
                        <a:rPr lang="en-US" sz="900" u="none" strike="noStrike" dirty="0" smtClean="0">
                          <a:effectLst/>
                        </a:rPr>
                        <a:t>/</a:t>
                      </a:r>
                    </a:p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Thymidine </a:t>
                      </a:r>
                      <a:r>
                        <a:rPr lang="en-US" sz="900" u="none" strike="noStrike" dirty="0">
                          <a:effectLst/>
                        </a:rPr>
                        <a:t>phosphorylas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3691168150"/>
                  </a:ext>
                </a:extLst>
              </a:tr>
              <a:tr h="53584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DGF-B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ntraxin 2/SA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ntraxin 3/TSG-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eriostin/OSF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ref-1/DLK-1/FA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rolifer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roprotein Convertase 9/PCSK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AG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BP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g3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sis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1133985244"/>
                  </a:ext>
                </a:extLst>
              </a:tr>
              <a:tr h="3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J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eference Spot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E-Selectin/CD62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P-Selectin/CD62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erpin E1/PAI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erpin F1/PED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hrombopoie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IM-1/KIM-1/HAVC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NF-</a:t>
                      </a:r>
                      <a:r>
                        <a:rPr lang="el-GR" sz="900" u="none" strike="noStrike">
                          <a:effectLst/>
                        </a:rPr>
                        <a:t>α</a:t>
                      </a:r>
                      <a:endParaRPr lang="el-GR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VCAM-1/CD1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VEGF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WISP-1/CCN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egative Contro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55" marR="2755" marT="2755" marB="0" anchor="b"/>
                </a:tc>
                <a:extLst>
                  <a:ext uri="{0D108BD9-81ED-4DB2-BD59-A6C34878D82A}">
                    <a16:rowId xmlns:a16="http://schemas.microsoft.com/office/drawing/2014/main" val="86848152"/>
                  </a:ext>
                </a:extLst>
              </a:tr>
            </a:tbl>
          </a:graphicData>
        </a:graphic>
      </p:graphicFrame>
      <p:grpSp>
        <p:nvGrpSpPr>
          <p:cNvPr id="33" name="Group 32"/>
          <p:cNvGrpSpPr/>
          <p:nvPr/>
        </p:nvGrpSpPr>
        <p:grpSpPr>
          <a:xfrm>
            <a:off x="1509524" y="390224"/>
            <a:ext cx="6124952" cy="2442973"/>
            <a:chOff x="156836" y="390224"/>
            <a:chExt cx="6124952" cy="2442973"/>
          </a:xfrm>
        </p:grpSpPr>
        <p:pic>
          <p:nvPicPr>
            <p:cNvPr id="4" name="Picture 1" descr="page1image11981280">
              <a:extLst>
                <a:ext uri="{FF2B5EF4-FFF2-40B4-BE49-F238E27FC236}">
                  <a16:creationId xmlns:a16="http://schemas.microsoft.com/office/drawing/2014/main" id="{143AF296-DB93-2347-9055-81CA565EE1C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76" t="5333" r="31296" b="75006"/>
            <a:stretch/>
          </p:blipFill>
          <p:spPr bwMode="auto">
            <a:xfrm>
              <a:off x="156836" y="390224"/>
              <a:ext cx="2985145" cy="107803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2D8224F-FEC8-6240-A519-491269FA27D0}"/>
                </a:ext>
              </a:extLst>
            </p:cNvPr>
            <p:cNvSpPr txBox="1"/>
            <p:nvPr/>
          </p:nvSpPr>
          <p:spPr>
            <a:xfrm>
              <a:off x="2366479" y="1185562"/>
              <a:ext cx="877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31596D8E-6ABE-DB47-9DC0-AB7641013F13}"/>
                </a:ext>
              </a:extLst>
            </p:cNvPr>
            <p:cNvSpPr/>
            <p:nvPr/>
          </p:nvSpPr>
          <p:spPr>
            <a:xfrm>
              <a:off x="1973582" y="1131854"/>
              <a:ext cx="266700" cy="147345"/>
            </a:xfrm>
            <a:prstGeom prst="ellipse">
              <a:avLst/>
            </a:prstGeom>
            <a:noFill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" name="Picture 1" descr="page1image11981280">
              <a:extLst>
                <a:ext uri="{FF2B5EF4-FFF2-40B4-BE49-F238E27FC236}">
                  <a16:creationId xmlns:a16="http://schemas.microsoft.com/office/drawing/2014/main" id="{143AF296-DB93-2347-9055-81CA565EE1C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76" t="26971" r="31296" b="52921"/>
            <a:stretch/>
          </p:blipFill>
          <p:spPr bwMode="auto">
            <a:xfrm>
              <a:off x="3222116" y="390224"/>
              <a:ext cx="2985145" cy="11025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DEDD897-A086-5C46-8FB9-0F24115C19D9}"/>
                </a:ext>
              </a:extLst>
            </p:cNvPr>
            <p:cNvSpPr txBox="1"/>
            <p:nvPr/>
          </p:nvSpPr>
          <p:spPr>
            <a:xfrm>
              <a:off x="5596985" y="1175402"/>
              <a:ext cx="6848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MA</a:t>
              </a:r>
            </a:p>
          </p:txBody>
        </p:sp>
        <p:pic>
          <p:nvPicPr>
            <p:cNvPr id="20" name="Picture 1" descr="page1image11981280">
              <a:extLst>
                <a:ext uri="{FF2B5EF4-FFF2-40B4-BE49-F238E27FC236}">
                  <a16:creationId xmlns:a16="http://schemas.microsoft.com/office/drawing/2014/main" id="{143AF296-DB93-2347-9055-81CA565EE1C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76" t="46875" r="31296" b="31358"/>
            <a:stretch/>
          </p:blipFill>
          <p:spPr bwMode="auto">
            <a:xfrm>
              <a:off x="156836" y="1588724"/>
              <a:ext cx="2985145" cy="11935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823E499-22DD-D443-9B41-A612AF447128}"/>
                </a:ext>
              </a:extLst>
            </p:cNvPr>
            <p:cNvSpPr txBox="1"/>
            <p:nvPr/>
          </p:nvSpPr>
          <p:spPr>
            <a:xfrm>
              <a:off x="2769352" y="2463865"/>
              <a:ext cx="4539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n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Picture 1" descr="page1image11981280">
              <a:extLst>
                <a:ext uri="{FF2B5EF4-FFF2-40B4-BE49-F238E27FC236}">
                  <a16:creationId xmlns:a16="http://schemas.microsoft.com/office/drawing/2014/main" id="{143AF296-DB93-2347-9055-81CA565EE1C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76" t="68370" r="31296" b="9904"/>
            <a:stretch/>
          </p:blipFill>
          <p:spPr bwMode="auto">
            <a:xfrm>
              <a:off x="3222116" y="1590933"/>
              <a:ext cx="2985145" cy="11913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21C260E-1FDC-CD4F-807A-5AA29DE11346}"/>
                </a:ext>
              </a:extLst>
            </p:cNvPr>
            <p:cNvSpPr txBox="1"/>
            <p:nvPr/>
          </p:nvSpPr>
          <p:spPr>
            <a:xfrm>
              <a:off x="5077548" y="2423225"/>
              <a:ext cx="12042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MA + </a:t>
              </a:r>
              <a:r>
                <a:rPr lang="en-US" dirty="0" err="1">
                  <a:latin typeface="Arial" panose="020B0604020202020204" pitchFamily="34" charset="0"/>
                  <a:cs typeface="Arial" panose="020B0604020202020204" pitchFamily="34" charset="0"/>
                </a:rPr>
                <a:t>Fn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Oval 21"/>
            <p:cNvSpPr/>
            <p:nvPr/>
          </p:nvSpPr>
          <p:spPr>
            <a:xfrm>
              <a:off x="4967321" y="1123785"/>
              <a:ext cx="286422" cy="14734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Oval 22"/>
            <p:cNvSpPr/>
            <p:nvPr/>
          </p:nvSpPr>
          <p:spPr>
            <a:xfrm>
              <a:off x="1886230" y="2411274"/>
              <a:ext cx="286422" cy="14734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Oval 23"/>
            <p:cNvSpPr/>
            <p:nvPr/>
          </p:nvSpPr>
          <p:spPr>
            <a:xfrm>
              <a:off x="4975063" y="2384298"/>
              <a:ext cx="286422" cy="147345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-12140" y="-9626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6189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195</Words>
  <Application>Microsoft Office PowerPoint</Application>
  <PresentationFormat>On-screen Show (4:3)</PresentationFormat>
  <Paragraphs>1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sey, Merry L</dc:creator>
  <cp:lastModifiedBy>Lindsey, Merry L</cp:lastModifiedBy>
  <cp:revision>6</cp:revision>
  <dcterms:created xsi:type="dcterms:W3CDTF">2019-05-29T23:28:26Z</dcterms:created>
  <dcterms:modified xsi:type="dcterms:W3CDTF">2019-05-29T23:55:41Z</dcterms:modified>
</cp:coreProperties>
</file>